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  <p:sldId id="259" r:id="rId5"/>
    <p:sldId id="272" r:id="rId6"/>
    <p:sldId id="273" r:id="rId7"/>
    <p:sldId id="274" r:id="rId8"/>
    <p:sldId id="275" r:id="rId9"/>
    <p:sldId id="276" r:id="rId10"/>
    <p:sldId id="277" r:id="rId11"/>
    <p:sldId id="308" r:id="rId12"/>
    <p:sldId id="278" r:id="rId13"/>
    <p:sldId id="279" r:id="rId14"/>
    <p:sldId id="309" r:id="rId15"/>
    <p:sldId id="281" r:id="rId16"/>
    <p:sldId id="280" r:id="rId17"/>
    <p:sldId id="282" r:id="rId18"/>
    <p:sldId id="283" r:id="rId19"/>
    <p:sldId id="284" r:id="rId20"/>
    <p:sldId id="285" r:id="rId21"/>
    <p:sldId id="286" r:id="rId22"/>
    <p:sldId id="287" r:id="rId23"/>
    <p:sldId id="310" r:id="rId24"/>
    <p:sldId id="288" r:id="rId25"/>
    <p:sldId id="289" r:id="rId26"/>
    <p:sldId id="290" r:id="rId27"/>
    <p:sldId id="291" r:id="rId28"/>
    <p:sldId id="292" r:id="rId29"/>
    <p:sldId id="293" r:id="rId30"/>
    <p:sldId id="295" r:id="rId31"/>
    <p:sldId id="294" r:id="rId3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9" d="100"/>
          <a:sy n="89" d="100"/>
        </p:scale>
        <p:origin x="131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34" Type="http://schemas.openxmlformats.org/officeDocument/2006/relationships/viewProps" Target="view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theme" Target="theme/theme1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6449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61382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117741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32705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1359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32201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39115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51321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27004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0750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47961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884694-D220-4FC6-9C4B-CA996C713B38}" type="datetimeFigureOut">
              <a:rPr lang="zh-CN" altLang="en-US" smtClean="0"/>
              <a:t>2022/10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DE1743-257E-4963-B223-B610EBB47B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5362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2.xml"/></Relationships>
</file>

<file path=ppt/slides/_rels/slide2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2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0" y="630657"/>
            <a:ext cx="9144000" cy="2387600"/>
          </a:xfrm>
        </p:spPr>
        <p:txBody>
          <a:bodyPr>
            <a:normAutofit/>
          </a:bodyPr>
          <a:lstStyle/>
          <a:p>
            <a:pPr>
              <a:lnSpc>
                <a:spcPct val="125000"/>
              </a:lnSpc>
            </a:pPr>
            <a:r>
              <a:rPr lang="en-US" altLang="zh-CN" sz="4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Trees of the Monkeypox Viruses</a:t>
            </a:r>
            <a:r>
              <a:rPr lang="en-US" altLang="zh-CN" sz="40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’ Genes or Sequences</a:t>
            </a:r>
            <a:endParaRPr lang="zh-CN" altLang="en-US" sz="4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748687"/>
            <a:ext cx="6858000" cy="1655762"/>
          </a:xfrm>
        </p:spPr>
        <p:txBody>
          <a:bodyPr>
            <a:normAutofit/>
          </a:bodyPr>
          <a:lstStyle/>
          <a:p>
            <a:pPr>
              <a:lnSpc>
                <a:spcPct val="125000"/>
              </a:lnSpc>
            </a:pPr>
            <a:r>
              <a:rPr lang="en-US" altLang="zh-CN" sz="2800" b="1" dirty="0" err="1" smtClean="0">
                <a:latin typeface="Bodoni MT Black" panose="02070A03080606020203" pitchFamily="18" charset="0"/>
                <a:cs typeface="Times New Roman" panose="02020603050405020304" pitchFamily="18" charset="0"/>
              </a:rPr>
              <a:t>Xiong</a:t>
            </a:r>
            <a:r>
              <a:rPr lang="en-US" altLang="zh-CN" sz="2800" b="1" dirty="0" smtClean="0">
                <a:latin typeface="Bodoni MT Black" panose="02070A03080606020203" pitchFamily="18" charset="0"/>
                <a:cs typeface="Times New Roman" panose="02020603050405020304" pitchFamily="18" charset="0"/>
              </a:rPr>
              <a:t>, et al</a:t>
            </a:r>
          </a:p>
          <a:p>
            <a:pPr>
              <a:lnSpc>
                <a:spcPct val="125000"/>
              </a:lnSpc>
            </a:pPr>
            <a:r>
              <a:rPr lang="en-US" altLang="zh-CN" sz="2800" b="1" dirty="0" smtClean="0">
                <a:latin typeface="Bodoni MT Black" panose="02070A03080606020203" pitchFamily="18" charset="0"/>
                <a:cs typeface="Times New Roman" panose="02020603050405020304" pitchFamily="18" charset="0"/>
              </a:rPr>
              <a:t>October 12, 2022</a:t>
            </a:r>
            <a:endParaRPr lang="zh-CN" altLang="en-US" sz="2800" b="1" dirty="0">
              <a:latin typeface="Bodoni MT Black" panose="02070A03080606020203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913895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-</a:t>
            </a:r>
            <a:r>
              <a:rPr lang="en-US" altLang="zh-CN" sz="2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lfn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08845" y="343083"/>
            <a:ext cx="5185710" cy="5655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632327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2342785"/>
            <a:ext cx="9144000" cy="1888976"/>
          </a:xfrm>
        </p:spPr>
        <p:txBody>
          <a:bodyPr>
            <a:normAutofit/>
          </a:bodyPr>
          <a:lstStyle/>
          <a:p>
            <a:pPr lvl="0" algn="ctr">
              <a:spcBef>
                <a:spcPts val="1000"/>
              </a:spcBef>
            </a:pPr>
            <a:r>
              <a:rPr lang="en-US" altLang="zh-CN" sz="67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wo-branch-plus </a:t>
            </a:r>
            <a:r>
              <a:rPr lang="en-US" altLang="zh-CN" sz="67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ype</a:t>
            </a:r>
            <a:r>
              <a:rPr lang="zh-CN" altLang="en-US" sz="60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zh-CN" altLang="en-US" sz="60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688171109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46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73344" y="379597"/>
            <a:ext cx="5164881" cy="56183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694918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5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68518" y="358331"/>
            <a:ext cx="5184298" cy="56490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774143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2342785"/>
            <a:ext cx="9144000" cy="1888976"/>
          </a:xfrm>
        </p:spPr>
        <p:txBody>
          <a:bodyPr>
            <a:normAutofit/>
          </a:bodyPr>
          <a:lstStyle/>
          <a:p>
            <a:pPr lvl="0" algn="ctr">
              <a:spcBef>
                <a:spcPts val="1000"/>
              </a:spcBef>
            </a:pPr>
            <a:r>
              <a:rPr lang="en-US" altLang="zh-CN" sz="67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One-branch </a:t>
            </a:r>
            <a:r>
              <a:rPr lang="en-US" altLang="zh-CN" sz="67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yp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85192479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3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894244" y="315801"/>
            <a:ext cx="5408877" cy="563843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081979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1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13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72207" y="432760"/>
            <a:ext cx="5105136" cy="555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9477257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2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19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75454" y="286937"/>
            <a:ext cx="5685362" cy="55397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915949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7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74538" y="347700"/>
            <a:ext cx="5327278" cy="555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6748113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4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1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16814" y="432759"/>
            <a:ext cx="5064470" cy="56224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5862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8649" y="672307"/>
            <a:ext cx="7886700" cy="1325563"/>
          </a:xfrm>
        </p:spPr>
        <p:txBody>
          <a:bodyPr>
            <a:normAutofit/>
          </a:bodyPr>
          <a:lstStyle/>
          <a:p>
            <a:pPr algn="ctr"/>
            <a:r>
              <a:rPr lang="en-US" altLang="zh-CN" sz="3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escriptions</a:t>
            </a:r>
            <a:endParaRPr lang="zh-CN" altLang="en-US" sz="3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900112" y="2175669"/>
            <a:ext cx="7343775" cy="2839244"/>
          </a:xfrm>
        </p:spPr>
        <p:txBody>
          <a:bodyPr/>
          <a:lstStyle/>
          <a:p>
            <a:pPr>
              <a:buFont typeface="Wingdings" panose="05000000000000000000" pitchFamily="2" charset="2"/>
              <a:buChar char="ü"/>
            </a:pP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labeled with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dot are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ferences, including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 </a:t>
            </a:r>
            <a:r>
              <a:rPr lang="en-US" altLang="zh-CN" sz="2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fseqs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pecified in the two databases and 8 collected earlier than the current epidemic of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22.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quences labeled with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urple dot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hose in sub-clade I of the West African clade.</a:t>
            </a:r>
          </a:p>
          <a:p>
            <a:pPr>
              <a:buFont typeface="Wingdings" panose="05000000000000000000" pitchFamily="2" charset="2"/>
              <a:buChar char="ü"/>
            </a:pP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hylogenetic tree of B14R gene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s placed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Figure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b, and D14L gene can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e detected in none of the 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omes </a:t>
            </a:r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altLang="zh-CN" sz="20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onkeypox</a:t>
            </a:r>
            <a:r>
              <a:rPr lang="en-US" altLang="zh-CN" sz="2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Viruses in 2022.</a:t>
            </a:r>
            <a:endParaRPr lang="en-US" altLang="zh-CN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49412810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1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92711" y="347701"/>
            <a:ext cx="5785588" cy="5627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50741336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6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4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42074" y="358330"/>
            <a:ext cx="5283362" cy="55852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9952878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7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4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45759" y="379596"/>
            <a:ext cx="5110099" cy="55682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8479626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2342785"/>
            <a:ext cx="9144000" cy="1888976"/>
          </a:xfrm>
        </p:spPr>
        <p:txBody>
          <a:bodyPr>
            <a:normAutofit/>
          </a:bodyPr>
          <a:lstStyle/>
          <a:p>
            <a:pPr lvl="0" algn="ctr">
              <a:spcBef>
                <a:spcPts val="1000"/>
              </a:spcBef>
            </a:pPr>
            <a:r>
              <a:rPr lang="en-US" altLang="zh-CN" sz="6700" b="1" dirty="0" smtClean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Irregular </a:t>
            </a:r>
            <a:r>
              <a:rPr lang="en-US" altLang="zh-CN" sz="67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yp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46225864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8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61576" y="400862"/>
            <a:ext cx="5095363" cy="55427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5851412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9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77936" y="411494"/>
            <a:ext cx="5326633" cy="55334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72061918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50942" y="485923"/>
            <a:ext cx="4997619" cy="543641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184650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1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2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35710" y="379597"/>
            <a:ext cx="5249914" cy="56021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35941985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2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magglutinin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32841" y="273270"/>
            <a:ext cx="5285523" cy="5749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9365233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3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6R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55739" y="305169"/>
            <a:ext cx="5185033" cy="56238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83025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0" y="2342785"/>
            <a:ext cx="9144000" cy="1888976"/>
          </a:xfrm>
        </p:spPr>
        <p:txBody>
          <a:bodyPr>
            <a:normAutofit/>
          </a:bodyPr>
          <a:lstStyle/>
          <a:p>
            <a:pPr lvl="0" algn="ctr">
              <a:spcBef>
                <a:spcPts val="1000"/>
              </a:spcBef>
            </a:pPr>
            <a:r>
              <a:rPr lang="en-US" altLang="zh-CN" sz="67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wo-branch type</a:t>
            </a:r>
            <a:r>
              <a:rPr lang="zh-CN" altLang="en-US" sz="60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/>
            </a:r>
            <a:br>
              <a:rPr lang="zh-CN" altLang="en-US" sz="6000" b="1" dirty="0">
                <a:solidFill>
                  <a:prstClr val="black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</a:b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838805692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4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7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871732" y="400862"/>
            <a:ext cx="5540830" cy="542578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5747000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内容占位符 5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21502" y="390229"/>
            <a:ext cx="5191679" cy="56422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18407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10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内容占位符 3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62010" y="343083"/>
            <a:ext cx="5185710" cy="56558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23779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altLang="zh-CN" sz="2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kbp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2009551" y="283904"/>
            <a:ext cx="5317200" cy="57355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780199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altLang="zh-CN" sz="28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rmB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829110" y="273272"/>
            <a:ext cx="5347866" cy="575811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512458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1L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25497" y="283903"/>
            <a:ext cx="5285177" cy="56809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240421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O1L_trctd Gen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764113" y="464657"/>
            <a:ext cx="5713790" cy="55533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78667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17317" y="5826642"/>
            <a:ext cx="7886700" cy="829452"/>
          </a:xfrm>
        </p:spPr>
        <p:txBody>
          <a:bodyPr>
            <a:normAutofit/>
          </a:bodyPr>
          <a:lstStyle/>
          <a:p>
            <a:pPr algn="ctr"/>
            <a:r>
              <a:rPr lang="en-US" altLang="zh-CN" sz="2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zh-CN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</a:t>
            </a:r>
            <a:r>
              <a:rPr lang="en-US" altLang="zh-CN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2 Sequence</a:t>
            </a:r>
            <a:endParaRPr lang="zh-CN" altLang="en-US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内容占位符 4"/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941981" y="283901"/>
            <a:ext cx="5358499" cy="56915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1578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</TotalTime>
  <Words>250</Words>
  <Application>Microsoft Office PowerPoint</Application>
  <PresentationFormat>全屏显示(4:3)</PresentationFormat>
  <Paragraphs>36</Paragraphs>
  <Slides>3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1</vt:i4>
      </vt:variant>
    </vt:vector>
  </HeadingPairs>
  <TitlesOfParts>
    <vt:vector size="40" baseType="lpstr">
      <vt:lpstr>等线</vt:lpstr>
      <vt:lpstr>等线 Light</vt:lpstr>
      <vt:lpstr>Arial</vt:lpstr>
      <vt:lpstr>Bodoni MT Black</vt:lpstr>
      <vt:lpstr>Calibri</vt:lpstr>
      <vt:lpstr>Calibri Light</vt:lpstr>
      <vt:lpstr>Times New Roman</vt:lpstr>
      <vt:lpstr>Wingdings</vt:lpstr>
      <vt:lpstr>Office 主题​​</vt:lpstr>
      <vt:lpstr>Phylogenetic Trees of the Monkeypox Viruses’ Genes or Sequences</vt:lpstr>
      <vt:lpstr>Descriptions</vt:lpstr>
      <vt:lpstr>Two-branch type </vt:lpstr>
      <vt:lpstr>Supplemental Figure 1. C10L Gene</vt:lpstr>
      <vt:lpstr>Supplemental Figure 2. Ckbp Gene</vt:lpstr>
      <vt:lpstr>Supplemental Figure 3. CrmB Gene</vt:lpstr>
      <vt:lpstr>Supplemental Figure 4. K1L Gene</vt:lpstr>
      <vt:lpstr>Supplemental Figure 5. O1L_trctd Gene</vt:lpstr>
      <vt:lpstr>Supplemental Figure 6. Rep2 Sequence</vt:lpstr>
      <vt:lpstr>Supplemental Figure 7. V-slfn Gene</vt:lpstr>
      <vt:lpstr>Two-branch-plus type </vt:lpstr>
      <vt:lpstr>Supplemental Figure 8. A46R Gene</vt:lpstr>
      <vt:lpstr>Supplemental Figure 9. B5R Gene</vt:lpstr>
      <vt:lpstr>One-branch type</vt:lpstr>
      <vt:lpstr>Supplemental Figure 10. E3L Gene</vt:lpstr>
      <vt:lpstr>Supplemental Figure 11. B13R Gene</vt:lpstr>
      <vt:lpstr>Supplemental Figure 12. B19R Gene</vt:lpstr>
      <vt:lpstr>Supplemental Figure 13. C7L Gene</vt:lpstr>
      <vt:lpstr>Supplemental Figure 14. D11L Gene</vt:lpstr>
      <vt:lpstr>Supplemental Figure 15. N1R Gene</vt:lpstr>
      <vt:lpstr>Supplemental Figure 16. T4 Gene</vt:lpstr>
      <vt:lpstr>Supplemental Figure 17. K4L Gene</vt:lpstr>
      <vt:lpstr>Irregular type</vt:lpstr>
      <vt:lpstr>Supplemental Figure 18. C1L Gene</vt:lpstr>
      <vt:lpstr>Supplemental Figure 19. P1L Gene</vt:lpstr>
      <vt:lpstr>Supplemental Figure 20. F1L Gene</vt:lpstr>
      <vt:lpstr>Supplemental Figure 21. N2L Gene</vt:lpstr>
      <vt:lpstr>Supplemental Figure 22. Hemagglutinin Gene</vt:lpstr>
      <vt:lpstr>Supplemental Figure 23. C6R Gene</vt:lpstr>
      <vt:lpstr>Supplemental Figure 24. D7L Gene</vt:lpstr>
      <vt:lpstr>Supplemental Figure 25. O1L Gene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hylogenetic Trees of the Monkeypox Viruses’ Gene or Sequence</dc:title>
  <dc:creator>Admin</dc:creator>
  <cp:lastModifiedBy>Admin</cp:lastModifiedBy>
  <cp:revision>14</cp:revision>
  <dcterms:created xsi:type="dcterms:W3CDTF">2022-10-13T07:27:16Z</dcterms:created>
  <dcterms:modified xsi:type="dcterms:W3CDTF">2022-10-13T09:16:00Z</dcterms:modified>
</cp:coreProperties>
</file>